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801600" cy="9601200" type="A3"/>
  <p:notesSz cx="6858000" cy="9144000"/>
  <p:defaultTextStyle>
    <a:defPPr>
      <a:defRPr lang="hu-HU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24">
          <p15:clr>
            <a:srgbClr val="A4A3A4"/>
          </p15:clr>
        </p15:guide>
        <p15:guide id="2" pos="403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1644" y="108"/>
      </p:cViewPr>
      <p:guideLst>
        <p:guide orient="horz" pos="3024"/>
        <p:guide pos="40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960120" y="2982596"/>
            <a:ext cx="10881360" cy="205803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920240" y="5440680"/>
            <a:ext cx="896112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9281160" y="384494"/>
            <a:ext cx="2880360" cy="819213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640080" y="384494"/>
            <a:ext cx="8427720" cy="819213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011238" y="6169661"/>
            <a:ext cx="10881360" cy="1906905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1011238" y="4069399"/>
            <a:ext cx="10881360" cy="2100262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640080" y="2240281"/>
            <a:ext cx="5654040" cy="63363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507480" y="2240281"/>
            <a:ext cx="5654040" cy="6336348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640080" y="2149158"/>
            <a:ext cx="5656263" cy="895667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40080" y="3044825"/>
            <a:ext cx="5656263" cy="5531803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503036" y="2149158"/>
            <a:ext cx="5658485" cy="895667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503036" y="3044825"/>
            <a:ext cx="5658485" cy="5531803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640081" y="382270"/>
            <a:ext cx="4211638" cy="162687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005070" y="382271"/>
            <a:ext cx="7156450" cy="8194358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640081" y="2009141"/>
            <a:ext cx="4211638" cy="6567488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2509203" y="6720840"/>
            <a:ext cx="7680960" cy="79343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2509203" y="857885"/>
            <a:ext cx="7680960" cy="576072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2509203" y="7514273"/>
            <a:ext cx="7680960" cy="1126807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640080" y="384493"/>
            <a:ext cx="11521440" cy="16002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640080" y="2240281"/>
            <a:ext cx="11521440" cy="6336348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640080" y="8898891"/>
            <a:ext cx="29870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4919B-4047-4DB1-8B39-23A42AEBA556}" type="datetimeFigureOut">
              <a:rPr lang="hu-HU" smtClean="0"/>
              <a:t>2016.05.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373880" y="8898891"/>
            <a:ext cx="40538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9174480" y="8898891"/>
            <a:ext cx="2987040" cy="511175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ADBC-3396-4FFB-9E58-A6AB70DCADD4}" type="slidenum">
              <a:rPr lang="hu-HU" smtClean="0"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1"/>
          <p:cNvSpPr txBox="1">
            <a:spLocks noChangeArrowheads="1"/>
          </p:cNvSpPr>
          <p:nvPr/>
        </p:nvSpPr>
        <p:spPr bwMode="auto">
          <a:xfrm>
            <a:off x="-7912" y="2958"/>
            <a:ext cx="362933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hu-HU" sz="20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hu-HU" sz="2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861"/>
          <a:stretch/>
        </p:blipFill>
        <p:spPr bwMode="auto">
          <a:xfrm>
            <a:off x="-7911" y="507014"/>
            <a:ext cx="4320479" cy="3920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Szövegdoboz 1"/>
          <p:cNvSpPr txBox="1">
            <a:spLocks noChangeArrowheads="1"/>
          </p:cNvSpPr>
          <p:nvPr/>
        </p:nvSpPr>
        <p:spPr bwMode="auto">
          <a:xfrm>
            <a:off x="568152" y="466944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LCN</a:t>
            </a:r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VTMLISGR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58"/>
          <a:stretch/>
        </p:blipFill>
        <p:spPr bwMode="auto">
          <a:xfrm>
            <a:off x="4154697" y="507014"/>
            <a:ext cx="4248472" cy="3920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Szövegdoboz 1"/>
          <p:cNvSpPr txBox="1">
            <a:spLocks noChangeArrowheads="1"/>
          </p:cNvSpPr>
          <p:nvPr/>
        </p:nvSpPr>
        <p:spPr bwMode="auto">
          <a:xfrm>
            <a:off x="4744616" y="480120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LCN</a:t>
            </a:r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HVAYIIR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19"/>
          <a:stretch/>
        </p:blipFill>
        <p:spPr bwMode="auto">
          <a:xfrm>
            <a:off x="8489032" y="507014"/>
            <a:ext cx="4320480" cy="39203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Szövegdoboz 1"/>
          <p:cNvSpPr txBox="1">
            <a:spLocks noChangeArrowheads="1"/>
          </p:cNvSpPr>
          <p:nvPr/>
        </p:nvSpPr>
        <p:spPr bwMode="auto">
          <a:xfrm>
            <a:off x="9065096" y="480120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LCN</a:t>
            </a:r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1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GLSTESILIP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56"/>
          <a:stretch/>
        </p:blipFill>
        <p:spPr bwMode="auto">
          <a:xfrm>
            <a:off x="-7912" y="5160640"/>
            <a:ext cx="4320479" cy="39203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Szövegdoboz 1"/>
          <p:cNvSpPr txBox="1">
            <a:spLocks noChangeArrowheads="1"/>
          </p:cNvSpPr>
          <p:nvPr/>
        </p:nvSpPr>
        <p:spPr bwMode="auto">
          <a:xfrm>
            <a:off x="568152" y="5079340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LTF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CGLVPVLAENY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04"/>
          <a:stretch/>
        </p:blipFill>
        <p:spPr bwMode="auto">
          <a:xfrm>
            <a:off x="4298712" y="5107049"/>
            <a:ext cx="4104457" cy="39739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Szövegdoboz 1"/>
          <p:cNvSpPr txBox="1">
            <a:spLocks noChangeArrowheads="1"/>
          </p:cNvSpPr>
          <p:nvPr/>
        </p:nvSpPr>
        <p:spPr bwMode="auto">
          <a:xfrm>
            <a:off x="4860922" y="5088632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LTF CLAENAGDVAFVK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51"/>
          <a:stretch/>
        </p:blipFill>
        <p:spPr bwMode="auto">
          <a:xfrm>
            <a:off x="8403168" y="5107049"/>
            <a:ext cx="4406343" cy="3973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Szövegdoboz 1"/>
          <p:cNvSpPr txBox="1">
            <a:spLocks noChangeArrowheads="1"/>
          </p:cNvSpPr>
          <p:nvPr/>
        </p:nvSpPr>
        <p:spPr bwMode="auto">
          <a:xfrm>
            <a:off x="8921080" y="5088632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IGLC SYSCQVTHEGSTVE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2008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1"/>
          <p:cNvSpPr txBox="1">
            <a:spLocks noChangeArrowheads="1"/>
          </p:cNvSpPr>
          <p:nvPr/>
        </p:nvSpPr>
        <p:spPr bwMode="auto">
          <a:xfrm>
            <a:off x="-7912" y="2958"/>
            <a:ext cx="362933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hu-HU" sz="20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hu-HU" sz="2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45"/>
          <a:stretch/>
        </p:blipFill>
        <p:spPr bwMode="auto">
          <a:xfrm>
            <a:off x="23755" y="480120"/>
            <a:ext cx="4320480" cy="39472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Szövegdoboz 1"/>
          <p:cNvSpPr txBox="1">
            <a:spLocks noChangeArrowheads="1"/>
          </p:cNvSpPr>
          <p:nvPr/>
        </p:nvSpPr>
        <p:spPr bwMode="auto">
          <a:xfrm>
            <a:off x="613266" y="336104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LACRT</a:t>
            </a:r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QELNPL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06"/>
          <a:stretch/>
        </p:blipFill>
        <p:spPr bwMode="auto">
          <a:xfrm>
            <a:off x="4069650" y="480120"/>
            <a:ext cx="4320480" cy="39338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Szövegdoboz 1"/>
          <p:cNvSpPr txBox="1">
            <a:spLocks noChangeArrowheads="1"/>
          </p:cNvSpPr>
          <p:nvPr/>
        </p:nvSpPr>
        <p:spPr bwMode="auto">
          <a:xfrm>
            <a:off x="4659161" y="336104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LACRT</a:t>
            </a:r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SILLTEQALA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2"/>
          <a:stretch/>
        </p:blipFill>
        <p:spPr bwMode="auto">
          <a:xfrm>
            <a:off x="8417024" y="475076"/>
            <a:ext cx="4320480" cy="3821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Szövegdoboz 1"/>
          <p:cNvSpPr txBox="1">
            <a:spLocks noChangeArrowheads="1"/>
          </p:cNvSpPr>
          <p:nvPr/>
        </p:nvSpPr>
        <p:spPr bwMode="auto">
          <a:xfrm>
            <a:off x="8993088" y="336104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smtClean="0">
                <a:latin typeface="Times New Roman" pitchFamily="18" charset="0"/>
                <a:cs typeface="Times New Roman" pitchFamily="18" charset="0"/>
              </a:rPr>
              <a:t>LPNA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QIFGDY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47"/>
          <a:stretch/>
        </p:blipFill>
        <p:spPr bwMode="auto">
          <a:xfrm>
            <a:off x="23755" y="5091873"/>
            <a:ext cx="4274957" cy="39891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Szövegdoboz 1"/>
          <p:cNvSpPr txBox="1">
            <a:spLocks noChangeArrowheads="1"/>
          </p:cNvSpPr>
          <p:nvPr/>
        </p:nvSpPr>
        <p:spPr bwMode="auto">
          <a:xfrm>
            <a:off x="608493" y="4935324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LYZ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GISLANWMCLA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86"/>
          <a:stretch/>
        </p:blipFill>
        <p:spPr bwMode="auto">
          <a:xfrm>
            <a:off x="4091772" y="5103614"/>
            <a:ext cx="4325252" cy="39891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Szövegdoboz 1"/>
          <p:cNvSpPr txBox="1">
            <a:spLocks noChangeArrowheads="1"/>
          </p:cNvSpPr>
          <p:nvPr/>
        </p:nvSpPr>
        <p:spPr bwMode="auto">
          <a:xfrm>
            <a:off x="4672608" y="4944616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LYZ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WESGYNT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2"/>
          <a:stretch/>
        </p:blipFill>
        <p:spPr bwMode="auto">
          <a:xfrm>
            <a:off x="8390129" y="5091873"/>
            <a:ext cx="4347375" cy="4000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Szövegdoboz 1"/>
          <p:cNvSpPr txBox="1">
            <a:spLocks noChangeArrowheads="1"/>
          </p:cNvSpPr>
          <p:nvPr/>
        </p:nvSpPr>
        <p:spPr bwMode="auto">
          <a:xfrm>
            <a:off x="8993088" y="4944616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DCD ENAGEDPGLA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192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zövegdoboz 1"/>
          <p:cNvSpPr txBox="1">
            <a:spLocks noChangeArrowheads="1"/>
          </p:cNvSpPr>
          <p:nvPr/>
        </p:nvSpPr>
        <p:spPr bwMode="auto">
          <a:xfrm>
            <a:off x="-7912" y="2958"/>
            <a:ext cx="362933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hu-HU" sz="20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hu-HU" sz="2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73"/>
          <a:stretch/>
        </p:blipFill>
        <p:spPr bwMode="auto">
          <a:xfrm>
            <a:off x="0" y="619092"/>
            <a:ext cx="4384576" cy="3821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Szövegdoboz 1"/>
          <p:cNvSpPr txBox="1">
            <a:spLocks noChangeArrowheads="1"/>
          </p:cNvSpPr>
          <p:nvPr/>
        </p:nvSpPr>
        <p:spPr bwMode="auto">
          <a:xfrm>
            <a:off x="540856" y="542836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PIP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 YTACLCDDNP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43"/>
          <a:stretch/>
        </p:blipFill>
        <p:spPr bwMode="auto">
          <a:xfrm>
            <a:off x="4168552" y="619092"/>
            <a:ext cx="4384576" cy="3821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Szövegdoboz 1"/>
          <p:cNvSpPr txBox="1">
            <a:spLocks noChangeArrowheads="1"/>
          </p:cNvSpPr>
          <p:nvPr/>
        </p:nvSpPr>
        <p:spPr bwMode="auto">
          <a:xfrm>
            <a:off x="4888632" y="552128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PIP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 TVQIAAVVDVI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49"/>
          <a:stretch/>
        </p:blipFill>
        <p:spPr bwMode="auto">
          <a:xfrm>
            <a:off x="8409112" y="629365"/>
            <a:ext cx="4392488" cy="38111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Szövegdoboz 1"/>
          <p:cNvSpPr txBox="1">
            <a:spLocks noChangeArrowheads="1"/>
          </p:cNvSpPr>
          <p:nvPr/>
        </p:nvSpPr>
        <p:spPr bwMode="auto">
          <a:xfrm>
            <a:off x="9137104" y="552128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AZGP1  DYIEFNK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37"/>
          <a:stretch/>
        </p:blipFill>
        <p:spPr bwMode="auto">
          <a:xfrm>
            <a:off x="0" y="5091873"/>
            <a:ext cx="4384576" cy="4000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Szövegdoboz 1"/>
          <p:cNvSpPr txBox="1">
            <a:spLocks noChangeArrowheads="1"/>
          </p:cNvSpPr>
          <p:nvPr/>
        </p:nvSpPr>
        <p:spPr bwMode="auto">
          <a:xfrm>
            <a:off x="640160" y="5086717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AZGP1 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IDVHWT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57"/>
          <a:stretch/>
        </p:blipFill>
        <p:spPr bwMode="auto">
          <a:xfrm>
            <a:off x="8345016" y="5091873"/>
            <a:ext cx="4456584" cy="4000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Szövegdoboz 1"/>
          <p:cNvSpPr txBox="1">
            <a:spLocks noChangeArrowheads="1"/>
          </p:cNvSpPr>
          <p:nvPr/>
        </p:nvSpPr>
        <p:spPr bwMode="auto">
          <a:xfrm>
            <a:off x="8921080" y="5088632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GAL3BP LASAYGA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57"/>
          <a:stretch/>
        </p:blipFill>
        <p:spPr bwMode="auto">
          <a:xfrm>
            <a:off x="4168553" y="5091873"/>
            <a:ext cx="4384576" cy="40008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Szövegdoboz 1"/>
          <p:cNvSpPr txBox="1">
            <a:spLocks noChangeArrowheads="1"/>
          </p:cNvSpPr>
          <p:nvPr/>
        </p:nvSpPr>
        <p:spPr bwMode="auto">
          <a:xfrm>
            <a:off x="4888632" y="5088632"/>
            <a:ext cx="3456384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hu-HU" sz="1800" dirty="0">
                <a:latin typeface="Times New Roman" pitchFamily="18" charset="0"/>
                <a:cs typeface="Times New Roman" pitchFamily="18" charset="0"/>
              </a:rPr>
              <a:t>GAL3BP </a:t>
            </a:r>
            <a:r>
              <a:rPr lang="hu-HU" sz="1800" dirty="0" smtClean="0">
                <a:latin typeface="Times New Roman" pitchFamily="18" charset="0"/>
                <a:cs typeface="Times New Roman" pitchFamily="18" charset="0"/>
              </a:rPr>
              <a:t> LADGGATNQGR</a:t>
            </a:r>
            <a:endParaRPr lang="hu-HU" sz="18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1528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45</Words>
  <Application>Microsoft Office PowerPoint</Application>
  <PresentationFormat>A3 (297x420 mm)</PresentationFormat>
  <Paragraphs>21</Paragraphs>
  <Slides>3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-téma</vt:lpstr>
      <vt:lpstr>PowerPoint bemutató</vt:lpstr>
      <vt:lpstr>PowerPoint bemutató</vt:lpstr>
      <vt:lpstr>PowerPoint bemutat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Gergő</dc:creator>
  <cp:lastModifiedBy>Éva</cp:lastModifiedBy>
  <cp:revision>16</cp:revision>
  <dcterms:created xsi:type="dcterms:W3CDTF">2015-07-24T10:35:58Z</dcterms:created>
  <dcterms:modified xsi:type="dcterms:W3CDTF">2016-05-05T06:14:27Z</dcterms:modified>
</cp:coreProperties>
</file>